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  <p:sldId id="257" r:id="rId4"/>
    <p:sldId id="258" r:id="rId5"/>
    <p:sldId id="259" r:id="rId6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8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orachet Promruk" userId="aaba62c3-139b-4f65-bf9a-0033c512a216" providerId="ADAL" clId="{C9D104B8-72F9-4BE2-8285-05A713CCE3C9}"/>
    <pc:docChg chg="undo custSel modSld">
      <pc:chgData name="Worachet Promruk" userId="aaba62c3-139b-4f65-bf9a-0033c512a216" providerId="ADAL" clId="{C9D104B8-72F9-4BE2-8285-05A713CCE3C9}" dt="2025-08-18T11:30:25.455" v="532" actId="164"/>
      <pc:docMkLst>
        <pc:docMk/>
      </pc:docMkLst>
      <pc:sldChg chg="addSp delSp modSp mod">
        <pc:chgData name="Worachet Promruk" userId="aaba62c3-139b-4f65-bf9a-0033c512a216" providerId="ADAL" clId="{C9D104B8-72F9-4BE2-8285-05A713CCE3C9}" dt="2025-08-18T11:30:25.455" v="532" actId="164"/>
        <pc:sldMkLst>
          <pc:docMk/>
          <pc:sldMk cId="650088095" sldId="256"/>
        </pc:sldMkLst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5" creationId="{0B627C5F-5958-40C7-9C6F-E0287F9F67E7}"/>
          </ac:spMkLst>
        </pc:spChg>
        <pc:spChg chg="mod">
          <ac:chgData name="Worachet Promruk" userId="aaba62c3-139b-4f65-bf9a-0033c512a216" providerId="ADAL" clId="{C9D104B8-72F9-4BE2-8285-05A713CCE3C9}" dt="2025-08-18T11:25:23.325" v="499" actId="20577"/>
          <ac:spMkLst>
            <pc:docMk/>
            <pc:sldMk cId="650088095" sldId="256"/>
            <ac:spMk id="10" creationId="{74E4D6FA-5712-494F-A999-28B9D85A2BB9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0" creationId="{1A2F458D-D5F8-4B11-8C7E-3A9731C46B2A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1" creationId="{52FC009B-B91B-449C-85CB-8C6A5D9BE0C0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2" creationId="{0CC91D86-FE25-42A5-9B59-0004343E24C8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3" creationId="{6EE7E21D-894D-4425-8203-BF6DDA51C350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4" creationId="{0263F8C1-E174-47F4-8B37-58A643BDA954}"/>
          </ac:spMkLst>
        </pc:spChg>
        <pc:spChg chg="add mod">
          <ac:chgData name="Worachet Promruk" userId="aaba62c3-139b-4f65-bf9a-0033c512a216" providerId="ADAL" clId="{C9D104B8-72F9-4BE2-8285-05A713CCE3C9}" dt="2025-08-18T11:30:25.455" v="532" actId="164"/>
          <ac:spMkLst>
            <pc:docMk/>
            <pc:sldMk cId="650088095" sldId="256"/>
            <ac:spMk id="27" creationId="{CB22C899-BDD7-46AE-85CE-4AAA22316110}"/>
          </ac:spMkLst>
        </pc:spChg>
        <pc:grpChg chg="add mod">
          <ac:chgData name="Worachet Promruk" userId="aaba62c3-139b-4f65-bf9a-0033c512a216" providerId="ADAL" clId="{C9D104B8-72F9-4BE2-8285-05A713CCE3C9}" dt="2025-08-18T11:30:25.455" v="532" actId="164"/>
          <ac:grpSpMkLst>
            <pc:docMk/>
            <pc:sldMk cId="650088095" sldId="256"/>
            <ac:grpSpMk id="7" creationId="{C57440E7-7F1A-4AD5-9B2D-587A1AF76714}"/>
          </ac:grpSpMkLst>
        </pc:grpChg>
        <pc:grpChg chg="add del mod">
          <ac:chgData name="Worachet Promruk" userId="aaba62c3-139b-4f65-bf9a-0033c512a216" providerId="ADAL" clId="{C9D104B8-72F9-4BE2-8285-05A713CCE3C9}" dt="2025-08-18T10:35:34.412" v="224" actId="21"/>
          <ac:grpSpMkLst>
            <pc:docMk/>
            <pc:sldMk cId="650088095" sldId="256"/>
            <ac:grpSpMk id="17" creationId="{78E470C0-760A-4FB8-8DD3-6494ECAE3A00}"/>
          </ac:grpSpMkLst>
        </pc:grpChg>
        <pc:picChg chg="add mod modCrop">
          <ac:chgData name="Worachet Promruk" userId="aaba62c3-139b-4f65-bf9a-0033c512a216" providerId="ADAL" clId="{C9D104B8-72F9-4BE2-8285-05A713CCE3C9}" dt="2025-08-18T10:34:24.409" v="176" actId="164"/>
          <ac:picMkLst>
            <pc:docMk/>
            <pc:sldMk cId="650088095" sldId="256"/>
            <ac:picMk id="3" creationId="{0F50280E-FE35-490C-A6B2-002A8A0D52CC}"/>
          </ac:picMkLst>
        </pc:picChg>
        <pc:picChg chg="mod">
          <ac:chgData name="Worachet Promruk" userId="aaba62c3-139b-4f65-bf9a-0033c512a216" providerId="ADAL" clId="{C9D104B8-72F9-4BE2-8285-05A713CCE3C9}" dt="2025-08-18T10:35:26.343" v="223" actId="1076"/>
          <ac:picMkLst>
            <pc:docMk/>
            <pc:sldMk cId="650088095" sldId="256"/>
            <ac:picMk id="4" creationId="{FF791C83-E05A-4E14-A577-0DD92F6D1377}"/>
          </ac:picMkLst>
        </pc:picChg>
        <pc:picChg chg="add mod modCrop">
          <ac:chgData name="Worachet Promruk" userId="aaba62c3-139b-4f65-bf9a-0033c512a216" providerId="ADAL" clId="{C9D104B8-72F9-4BE2-8285-05A713CCE3C9}" dt="2025-08-18T10:34:24.409" v="176" actId="164"/>
          <ac:picMkLst>
            <pc:docMk/>
            <pc:sldMk cId="650088095" sldId="256"/>
            <ac:picMk id="6" creationId="{8074EE23-A465-43CB-8E6A-3CDD26C9157F}"/>
          </ac:picMkLst>
        </pc:picChg>
        <pc:picChg chg="del mod">
          <ac:chgData name="Worachet Promruk" userId="aaba62c3-139b-4f65-bf9a-0033c512a216" providerId="ADAL" clId="{C9D104B8-72F9-4BE2-8285-05A713CCE3C9}" dt="2025-08-18T10:42:41.738" v="341" actId="478"/>
          <ac:picMkLst>
            <pc:docMk/>
            <pc:sldMk cId="650088095" sldId="256"/>
            <ac:picMk id="7" creationId="{25948992-EE22-47B0-96C4-EAF0E529D3BA}"/>
          </ac:picMkLst>
        </pc:picChg>
        <pc:picChg chg="add mod modCrop">
          <ac:chgData name="Worachet Promruk" userId="aaba62c3-139b-4f65-bf9a-0033c512a216" providerId="ADAL" clId="{C9D104B8-72F9-4BE2-8285-05A713CCE3C9}" dt="2025-08-18T10:34:24.409" v="176" actId="164"/>
          <ac:picMkLst>
            <pc:docMk/>
            <pc:sldMk cId="650088095" sldId="256"/>
            <ac:picMk id="9" creationId="{FE77668A-4545-49E6-AF36-7C569CF1C445}"/>
          </ac:picMkLst>
        </pc:picChg>
        <pc:picChg chg="add mod modCrop">
          <ac:chgData name="Worachet Promruk" userId="aaba62c3-139b-4f65-bf9a-0033c512a216" providerId="ADAL" clId="{C9D104B8-72F9-4BE2-8285-05A713CCE3C9}" dt="2025-08-18T10:34:24.409" v="176" actId="164"/>
          <ac:picMkLst>
            <pc:docMk/>
            <pc:sldMk cId="650088095" sldId="256"/>
            <ac:picMk id="12" creationId="{CA1DA42C-F0B8-473C-A715-7FC6E27ACDC5}"/>
          </ac:picMkLst>
        </pc:picChg>
        <pc:picChg chg="add mod modCrop">
          <ac:chgData name="Worachet Promruk" userId="aaba62c3-139b-4f65-bf9a-0033c512a216" providerId="ADAL" clId="{C9D104B8-72F9-4BE2-8285-05A713CCE3C9}" dt="2025-08-18T10:34:24.409" v="176" actId="164"/>
          <ac:picMkLst>
            <pc:docMk/>
            <pc:sldMk cId="650088095" sldId="256"/>
            <ac:picMk id="14" creationId="{9BCF6732-63D2-4D59-8773-024070520D8B}"/>
          </ac:picMkLst>
        </pc:picChg>
        <pc:picChg chg="add mod modCrop">
          <ac:chgData name="Worachet Promruk" userId="aaba62c3-139b-4f65-bf9a-0033c512a216" providerId="ADAL" clId="{C9D104B8-72F9-4BE2-8285-05A713CCE3C9}" dt="2025-08-18T10:35:19.631" v="221" actId="14100"/>
          <ac:picMkLst>
            <pc:docMk/>
            <pc:sldMk cId="650088095" sldId="256"/>
            <ac:picMk id="16" creationId="{25B66349-82EF-4C9B-ADBF-992530A58512}"/>
          </ac:picMkLst>
        </pc:picChg>
        <pc:picChg chg="add del mod">
          <ac:chgData name="Worachet Promruk" userId="aaba62c3-139b-4f65-bf9a-0033c512a216" providerId="ADAL" clId="{C9D104B8-72F9-4BE2-8285-05A713CCE3C9}" dt="2025-08-18T10:35:09.241" v="219"/>
          <ac:picMkLst>
            <pc:docMk/>
            <pc:sldMk cId="650088095" sldId="256"/>
            <ac:picMk id="18" creationId="{BC9FA158-CEA4-4410-95B6-F8C6967A8FD7}"/>
          </ac:picMkLst>
        </pc:picChg>
        <pc:picChg chg="add mod">
          <ac:chgData name="Worachet Promruk" userId="aaba62c3-139b-4f65-bf9a-0033c512a216" providerId="ADAL" clId="{C9D104B8-72F9-4BE2-8285-05A713CCE3C9}" dt="2025-08-18T11:30:25.455" v="532" actId="164"/>
          <ac:picMkLst>
            <pc:docMk/>
            <pc:sldMk cId="650088095" sldId="256"/>
            <ac:picMk id="19" creationId="{3EBDBFB9-C2FC-476E-8760-7B854E6935EA}"/>
          </ac:picMkLst>
        </pc:picChg>
        <pc:picChg chg="add mod">
          <ac:chgData name="Worachet Promruk" userId="aaba62c3-139b-4f65-bf9a-0033c512a216" providerId="ADAL" clId="{C9D104B8-72F9-4BE2-8285-05A713CCE3C9}" dt="2025-08-18T10:45:00.678" v="358" actId="1036"/>
          <ac:picMkLst>
            <pc:docMk/>
            <pc:sldMk cId="650088095" sldId="256"/>
            <ac:picMk id="26" creationId="{9A165ED8-F848-43FC-845E-D7F1A89E77A8}"/>
          </ac:picMkLst>
        </pc:picChg>
        <pc:cxnChg chg="add mod">
          <ac:chgData name="Worachet Promruk" userId="aaba62c3-139b-4f65-bf9a-0033c512a216" providerId="ADAL" clId="{C9D104B8-72F9-4BE2-8285-05A713CCE3C9}" dt="2025-08-18T11:30:25.455" v="532" actId="164"/>
          <ac:cxnSpMkLst>
            <pc:docMk/>
            <pc:sldMk cId="650088095" sldId="256"/>
            <ac:cxnSpMk id="3" creationId="{7D4AC030-BDAE-46C9-8338-F27073042452}"/>
          </ac:cxnSpMkLst>
        </pc:cxnChg>
      </pc:sldChg>
      <pc:sldChg chg="addSp delSp modSp mod">
        <pc:chgData name="Worachet Promruk" userId="aaba62c3-139b-4f65-bf9a-0033c512a216" providerId="ADAL" clId="{C9D104B8-72F9-4BE2-8285-05A713CCE3C9}" dt="2025-08-18T11:25:07.625" v="496" actId="20577"/>
        <pc:sldMkLst>
          <pc:docMk/>
          <pc:sldMk cId="3728902223" sldId="260"/>
        </pc:sldMkLst>
        <pc:spChg chg="mod">
          <ac:chgData name="Worachet Promruk" userId="aaba62c3-139b-4f65-bf9a-0033c512a216" providerId="ADAL" clId="{C9D104B8-72F9-4BE2-8285-05A713CCE3C9}" dt="2025-08-18T11:25:07.625" v="496" actId="20577"/>
          <ac:spMkLst>
            <pc:docMk/>
            <pc:sldMk cId="3728902223" sldId="260"/>
            <ac:spMk id="10" creationId="{15BA996F-5953-4B9D-91AB-E1F19F4A9ECB}"/>
          </ac:spMkLst>
        </pc:spChg>
        <pc:picChg chg="del">
          <ac:chgData name="Worachet Promruk" userId="aaba62c3-139b-4f65-bf9a-0033c512a216" providerId="ADAL" clId="{C9D104B8-72F9-4BE2-8285-05A713CCE3C9}" dt="2025-08-18T11:20:19.422" v="453" actId="478"/>
          <ac:picMkLst>
            <pc:docMk/>
            <pc:sldMk cId="3728902223" sldId="260"/>
            <ac:picMk id="3" creationId="{81B20F92-382F-48B8-BE41-198C2A6A7788}"/>
          </ac:picMkLst>
        </pc:picChg>
        <pc:picChg chg="add del mod">
          <ac:chgData name="Worachet Promruk" userId="aaba62c3-139b-4f65-bf9a-0033c512a216" providerId="ADAL" clId="{C9D104B8-72F9-4BE2-8285-05A713CCE3C9}" dt="2025-08-18T11:20:32.331" v="456" actId="478"/>
          <ac:picMkLst>
            <pc:docMk/>
            <pc:sldMk cId="3728902223" sldId="260"/>
            <ac:picMk id="5" creationId="{B9960ADE-F4E3-4C54-B8D5-C20CC8CA4F4B}"/>
          </ac:picMkLst>
        </pc:picChg>
        <pc:picChg chg="add mod">
          <ac:chgData name="Worachet Promruk" userId="aaba62c3-139b-4f65-bf9a-0033c512a216" providerId="ADAL" clId="{C9D104B8-72F9-4BE2-8285-05A713CCE3C9}" dt="2025-08-18T11:23:12.472" v="473" actId="1035"/>
          <ac:picMkLst>
            <pc:docMk/>
            <pc:sldMk cId="3728902223" sldId="260"/>
            <ac:picMk id="7" creationId="{4DB7C934-7F35-4E62-A9EB-7D029C3303E6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7033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9893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58023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7651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9669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9811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749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266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45566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4714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80220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10012A-326D-429D-BBFF-C49703ABEC52}" type="datetimeFigureOut">
              <a:rPr lang="en-GB" smtClean="0"/>
              <a:t>25/08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9407B-BD0F-46CE-9BDF-84C17863220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344432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6.png"/><Relationship Id="rId4" Type="http://schemas.openxmlformats.org/officeDocument/2006/relationships/image" Target="../media/image5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8.sv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0.sv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91C83-E05A-4E14-A577-0DD92F6D137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366" y="238514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8EDD85C-A1D6-458E-A516-09D976FE09D7}"/>
              </a:ext>
            </a:extLst>
          </p:cNvPr>
          <p:cNvSpPr txBox="1"/>
          <p:nvPr/>
        </p:nvSpPr>
        <p:spPr>
          <a:xfrm>
            <a:off x="1713556" y="735084"/>
            <a:ext cx="343088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>
              <a:spcBef>
                <a:spcPts val="1200"/>
              </a:spcBef>
              <a:spcAft>
                <a:spcPts val="600"/>
              </a:spcAft>
            </a:pPr>
            <a:r>
              <a:rPr lang="en-US" sz="1800" b="1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Material</a:t>
            </a:r>
            <a:endParaRPr lang="en-GB" sz="1800" b="1" i="1" dirty="0"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5BA996F-5953-4B9D-91AB-E1F19F4A9ECB}"/>
              </a:ext>
            </a:extLst>
          </p:cNvPr>
          <p:cNvSpPr txBox="1"/>
          <p:nvPr/>
        </p:nvSpPr>
        <p:spPr>
          <a:xfrm>
            <a:off x="266023" y="6908679"/>
            <a:ext cx="632595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1. Micro-CT analysis of tibial cortical bon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-dimentional images of tibial cortical bone compartment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Quantification of whole bone analyses of cortical bone between 10 and 90% of total tibial length, excluding proximal and distal metaphyseal bone, of CTRL and CKD tibia after 1-weeks’ induction.  (B) cortical bone area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B.Ar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, (C) thickness, (D) maximum moment of inertia (MMI max), (E) minimum moment of inertia (MMI min) and (F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J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- polar moment of inertia were all similar between control and CKD mice. Data are presented as mean ± SEM, n = 5 - 6 bones per group.</a:t>
            </a:r>
            <a:endParaRPr lang="en-GB" sz="1200" dirty="0"/>
          </a:p>
        </p:txBody>
      </p:sp>
      <p:pic>
        <p:nvPicPr>
          <p:cNvPr id="7" name="Graphic 6">
            <a:extLst>
              <a:ext uri="{FF2B5EF4-FFF2-40B4-BE49-F238E27FC236}">
                <a16:creationId xmlns:a16="http://schemas.microsoft.com/office/drawing/2014/main" id="{4DB7C934-7F35-4E62-A9EB-7D029C3303E6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144654" y="1222872"/>
            <a:ext cx="6480373" cy="54922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8902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91C83-E05A-4E14-A577-0DD92F6D137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366" y="238514"/>
            <a:ext cx="1382395" cy="496570"/>
          </a:xfrm>
          <a:prstGeom prst="rect">
            <a:avLst/>
          </a:prstGeom>
          <a:noFill/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4E4D6FA-5712-494F-A999-28B9D85A2BB9}"/>
              </a:ext>
            </a:extLst>
          </p:cNvPr>
          <p:cNvSpPr txBox="1"/>
          <p:nvPr/>
        </p:nvSpPr>
        <p:spPr>
          <a:xfrm>
            <a:off x="266023" y="8407605"/>
            <a:ext cx="632595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. Micro-CT analysis of tibial trabecular bon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-dimentional images of tibial trabecular bone compartment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rabecular (B) bone mineral density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b.BMD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(C) bone volume fraction (Tb.BV/TV), (D), thicknes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b.Th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, (E) number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b.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nd (G) connectivity density (Tb. 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nn.Den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but not (F) separatio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b.Sp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were decreased in CKD mice after 5 weeks’ induction. Data are presented as mean ± SEM with each dot representing an individual mouse.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, not significant, 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5, 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1, *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01.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6" name="Graphic 25">
            <a:extLst>
              <a:ext uri="{FF2B5EF4-FFF2-40B4-BE49-F238E27FC236}">
                <a16:creationId xmlns:a16="http://schemas.microsoft.com/office/drawing/2014/main" id="{9A165ED8-F848-43FC-845E-D7F1A89E77A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25119" y="3594676"/>
            <a:ext cx="6092760" cy="4746825"/>
          </a:xfrm>
          <a:prstGeom prst="rect">
            <a:avLst/>
          </a:prstGeom>
        </p:spPr>
      </p:pic>
      <p:grpSp>
        <p:nvGrpSpPr>
          <p:cNvPr id="7" name="Group 6">
            <a:extLst>
              <a:ext uri="{FF2B5EF4-FFF2-40B4-BE49-F238E27FC236}">
                <a16:creationId xmlns:a16="http://schemas.microsoft.com/office/drawing/2014/main" id="{C57440E7-7F1A-4AD5-9B2D-587A1AF76714}"/>
              </a:ext>
            </a:extLst>
          </p:cNvPr>
          <p:cNvGrpSpPr/>
          <p:nvPr/>
        </p:nvGrpSpPr>
        <p:grpSpPr>
          <a:xfrm>
            <a:off x="946160" y="766088"/>
            <a:ext cx="4476801" cy="2759302"/>
            <a:chOff x="946160" y="766088"/>
            <a:chExt cx="4476801" cy="2759302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3EBDBFB9-C2FC-476E-8760-7B854E6935E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567256" y="986432"/>
              <a:ext cx="3855705" cy="2538958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1A2F458D-D5F8-4B11-8C7E-3A9731C46B2A}"/>
                </a:ext>
              </a:extLst>
            </p:cNvPr>
            <p:cNvSpPr txBox="1"/>
            <p:nvPr/>
          </p:nvSpPr>
          <p:spPr>
            <a:xfrm>
              <a:off x="1567255" y="766090"/>
              <a:ext cx="1087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 week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2FC009B-B91B-449C-85CB-8C6A5D9BE0C0}"/>
                </a:ext>
              </a:extLst>
            </p:cNvPr>
            <p:cNvSpPr txBox="1"/>
            <p:nvPr/>
          </p:nvSpPr>
          <p:spPr>
            <a:xfrm>
              <a:off x="2839707" y="766089"/>
              <a:ext cx="1087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 week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0CC91D86-FE25-42A5-9B59-0004343E24C8}"/>
                </a:ext>
              </a:extLst>
            </p:cNvPr>
            <p:cNvSpPr txBox="1"/>
            <p:nvPr/>
          </p:nvSpPr>
          <p:spPr>
            <a:xfrm>
              <a:off x="4186419" y="766088"/>
              <a:ext cx="1087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5 weeks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EE7E21D-894D-4425-8203-BF6DDA51C350}"/>
                </a:ext>
              </a:extLst>
            </p:cNvPr>
            <p:cNvSpPr txBox="1"/>
            <p:nvPr/>
          </p:nvSpPr>
          <p:spPr>
            <a:xfrm rot="16200000">
              <a:off x="864884" y="1463335"/>
              <a:ext cx="1087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263F8C1-E174-47F4-8B37-58A643BDA954}"/>
                </a:ext>
              </a:extLst>
            </p:cNvPr>
            <p:cNvSpPr txBox="1"/>
            <p:nvPr/>
          </p:nvSpPr>
          <p:spPr>
            <a:xfrm rot="16200000">
              <a:off x="864883" y="2734602"/>
              <a:ext cx="10878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KD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22C899-BDD7-46AE-85CE-4AAA22316110}"/>
                </a:ext>
              </a:extLst>
            </p:cNvPr>
            <p:cNvSpPr txBox="1"/>
            <p:nvPr/>
          </p:nvSpPr>
          <p:spPr>
            <a:xfrm>
              <a:off x="946160" y="766088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b="1" dirty="0"/>
                <a:t>A</a:t>
              </a:r>
            </a:p>
          </p:txBody>
        </p:sp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7D4AC030-BDAE-46C9-8338-F27073042452}"/>
                </a:ext>
              </a:extLst>
            </p:cNvPr>
            <p:cNvCxnSpPr>
              <a:cxnSpLocks/>
            </p:cNvCxnSpPr>
            <p:nvPr/>
          </p:nvCxnSpPr>
          <p:spPr>
            <a:xfrm>
              <a:off x="1647161" y="3457826"/>
              <a:ext cx="557196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0B627C5F-5958-40C7-9C6F-E0287F9F67E7}"/>
                </a:ext>
              </a:extLst>
            </p:cNvPr>
            <p:cNvSpPr txBox="1"/>
            <p:nvPr/>
          </p:nvSpPr>
          <p:spPr>
            <a:xfrm>
              <a:off x="1698009" y="3276096"/>
              <a:ext cx="4539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m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6500880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91C83-E05A-4E14-A577-0DD92F6D137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366" y="238514"/>
            <a:ext cx="1382395" cy="49657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CDE49389-3984-4BA2-A2D5-627B4A9AAF6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409039" y="1342417"/>
            <a:ext cx="6161487" cy="156797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8C53362-F165-427C-B398-797B93304FAA}"/>
              </a:ext>
            </a:extLst>
          </p:cNvPr>
          <p:cNvSpPr txBox="1"/>
          <p:nvPr/>
        </p:nvSpPr>
        <p:spPr>
          <a:xfrm>
            <a:off x="266023" y="3433959"/>
            <a:ext cx="6325953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3. Regional quantification of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MAT accumulation in the tibial bone shaft.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ne marrow adipose tissue (BMAT) in CKD mice at (A) proximal epiphysis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x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pi) and (B) growth plate to tibia-fibula junctio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MA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P-T/F J) was increased in CKD mice after 5-weeks’ induction whereas BMAT in the (C) tibia-fibula junction to distal end regio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BMA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T/F J-End) and (D) whole tibial cavity was increased after 3- and 5-weeks’ induction. Data are presented as mean ± SEM with each dot representing an individual mouse.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, not significant, 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1, *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01. 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806309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91C83-E05A-4E14-A577-0DD92F6D137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366" y="238514"/>
            <a:ext cx="1382395" cy="49657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39B3AF23-4FAE-488A-9154-FB78E88F6C9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254237" y="1065989"/>
            <a:ext cx="6325953" cy="48021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CA54584-01AD-46F8-9366-C716A2500117}"/>
              </a:ext>
            </a:extLst>
          </p:cNvPr>
          <p:cNvSpPr txBox="1"/>
          <p:nvPr/>
        </p:nvSpPr>
        <p:spPr>
          <a:xfrm>
            <a:off x="266023" y="6308834"/>
            <a:ext cx="6325953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4. Body weight, food and calorie intake and BMAT accumulation in pair-fed mice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A) Body weight of CTRL and CKD mice increased and decreased, respectively over the experimental period.   The CKD mice lost more body weight than the pair-fed mice despite a similar (B) food and (C) caloric intake. (D) Bone marrow adipose tissue (BMAT) accumulation was similar between CTRL and pair-fed mice but was increased in growth plate to the tibia-fibula junction region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BMA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GP-T/F J), and the tibia-fibula junction to the distal end (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BMAT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; T/F J-End) of the CKD mice. Data are expressed as mean ± SEM, with each data point representing an individual mouse. 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s, not significant, 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5, 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1, *** </a:t>
            </a:r>
            <a:r>
              <a:rPr lang="en-US" sz="1200" i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01.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69696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F791C83-E05A-4E14-A577-0DD92F6D1377}"/>
              </a:ext>
            </a:extLst>
          </p:cNvPr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3366" y="238514"/>
            <a:ext cx="1382395" cy="496570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Graphic 2">
            <a:extLst>
              <a:ext uri="{FF2B5EF4-FFF2-40B4-BE49-F238E27FC236}">
                <a16:creationId xmlns:a16="http://schemas.microsoft.com/office/drawing/2014/main" id="{54084154-BAB3-4E65-B624-C610778C334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37728" y="1187508"/>
            <a:ext cx="5757907" cy="2934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32554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2</TotalTime>
  <Words>566</Words>
  <Application>Microsoft Office PowerPoint</Application>
  <PresentationFormat>A4 Paper (210x297 mm)</PresentationFormat>
  <Paragraphs>12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orachet Promruk</dc:creator>
  <cp:lastModifiedBy>Maarten Vandijck</cp:lastModifiedBy>
  <cp:revision>7</cp:revision>
  <dcterms:created xsi:type="dcterms:W3CDTF">2025-07-15T11:33:30Z</dcterms:created>
  <dcterms:modified xsi:type="dcterms:W3CDTF">2025-08-25T12:53:30Z</dcterms:modified>
</cp:coreProperties>
</file>